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0" r:id="rId2"/>
    <p:sldId id="261" r:id="rId3"/>
    <p:sldId id="263" r:id="rId4"/>
    <p:sldId id="262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 showGuides="1">
      <p:cViewPr varScale="1">
        <p:scale>
          <a:sx n="109" d="100"/>
          <a:sy n="109" d="100"/>
        </p:scale>
        <p:origin x="6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D55259-DEDC-3848-B0D4-D687AC27CCF1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937047-65D2-284F-A471-66134FBCAB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1668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937047-65D2-284F-A471-66134FBCAB7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24171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937047-65D2-284F-A471-66134FBCAB7B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1777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31FD6ACF-6095-3347-BFDA-256E73949F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9E9C76F5-1E7F-854D-9615-57BC16FDD9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E34CB7BC-6EB7-234D-B42D-D33A2F44A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C9D08DB5-9C0D-074D-BB1E-9E6AF4E35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37BD8B91-106B-2B43-AE39-4A49E82B8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1139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F35135DB-9887-B74F-A6DA-EB68B9F10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513BC861-F0E0-F344-A643-DE0D1E4ED3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744090DC-5FF2-354B-9588-8126DD97F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4F205DEF-3CFD-1D4B-91ED-4311B6469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1C880566-50C1-8948-84EA-94013986D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9847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5367342B-4B5C-FD4C-A10C-64297696FE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A0A55AAD-91A4-3341-9C84-5852D802BF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CF000E6-F203-004C-A490-E2E2CCC37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3B8E4FD6-B59F-F146-9C26-015BE879D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39F2D83D-FF25-AB4B-BAC9-325D793DB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5111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BC7D028-56C9-2344-B722-FD796ACFBD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B34F3CFB-F398-4B4A-BB09-8093C579E1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B0C893D9-CCD9-0A4B-9BE2-55BFBA40B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34BCEB8C-958B-A84B-ACD3-99D6E964D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75815071-3E3F-F641-BECC-2E28B8EEC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6579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DBB5AB1-EADA-7747-91F9-352FE8E386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6DBBD827-0962-6249-AA04-7F1A407B51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CA2DCF94-00CC-0848-A6EE-22FAF1802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098ADC95-6B81-354D-B120-95838AA7E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903D109-A237-834F-AD3A-F0C2490B1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4977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DAD4A6B-A531-104C-89C7-122599183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CC1477E4-C724-A041-91B6-7FD11A9A4B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4D80E054-7FB3-8346-8E5E-13DF3A0986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1094779B-918E-0C45-B9FD-DE04EC445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8FC84377-3416-ED41-8386-958D9A817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A75BBD39-AACD-4648-9E6E-2C9BA0459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356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86FB469D-1D4B-8842-A9DC-A1CFE4A0C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980D831B-7A96-844E-AE2A-7EA7341C5B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B37E8ECD-BFF0-DA4D-8D12-473AF24EE7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CF919F07-2FD8-CE45-8463-E830AA1098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6EB70157-915D-0B4F-9D66-607658E736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382351D6-1DD2-9647-A706-57CBBE4B0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96395322-2011-674B-87D6-F9AB49A21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CD4500EC-3759-1142-B7D9-2ACC0E7C9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408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98443B09-9395-C443-875E-3E423D3BC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616A1BAE-E24C-3047-8921-3C19A98BC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AC8337E3-C32A-5D49-854B-E9D441930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16F9F19C-59EF-5445-A7BC-9E63DE574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386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4107E3C7-14EB-C84A-B423-530850BED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42C90F7F-3C60-0349-8471-5D292E5E3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DF4FBD88-7F66-B645-8794-EBC2781DC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6851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8F4EBF27-3377-3748-900A-AC906FB77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7DCA9666-D0D8-604B-89BB-EDA4B1B0EC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6BC03837-E983-1F45-AEA6-A909AF69F2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DFD4D080-9CA5-774B-98F4-DD79FFD1D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0CF50CFE-A543-764F-9E84-44C6E29F0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6157F8FB-2088-9345-A0B2-03407E5CA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9113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CEF2E38B-F78D-DE42-8FB0-14D162B24E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F258B8D9-0403-EC45-ABDE-9A6250A86F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38464822-7271-7543-A7C7-2B06ED744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BF5E78B8-C2FF-014B-9E74-654A5F872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8DBF6F28-3518-5E43-8E6F-2C145E66B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86C17BEC-F710-3D40-A060-35DCAC264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92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3602ADB4-6284-AE43-896B-DCD31C153F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7FED2AC0-F7FA-ED47-B936-62A0ECB9A4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1623B770-02E8-164A-AE3D-308A7D8A38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DA25D-9E1B-1944-A01C-60C8AFF7D316}" type="datetimeFigureOut">
              <a:rPr lang="de-DE" smtClean="0"/>
              <a:t>28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6E2D787B-A9C3-2C44-BBF7-86F5DFD954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B80C887-22F2-D343-8EFA-E838008405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3A54B-06A0-AB42-8F10-270A1D616A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3459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7F86DC20-81BE-C44A-A47C-E3FA37C330E3}"/>
              </a:ext>
            </a:extLst>
          </p:cNvPr>
          <p:cNvSpPr txBox="1"/>
          <p:nvPr/>
        </p:nvSpPr>
        <p:spPr>
          <a:xfrm>
            <a:off x="701633" y="220138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1a: Progression-</a:t>
            </a:r>
            <a:r>
              <a:rPr lang="de-DE" dirty="0" err="1"/>
              <a:t>free</a:t>
            </a:r>
            <a:r>
              <a:rPr lang="de-DE" dirty="0"/>
              <a:t>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argeted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vs. </a:t>
            </a:r>
            <a:r>
              <a:rPr lang="de-DE" dirty="0" err="1"/>
              <a:t>doublet</a:t>
            </a:r>
            <a:r>
              <a:rPr lang="de-DE" dirty="0"/>
              <a:t>/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633B9668-D21A-3D41-9722-0B3F9E25BD47}"/>
              </a:ext>
            </a:extLst>
          </p:cNvPr>
          <p:cNvSpPr txBox="1"/>
          <p:nvPr/>
        </p:nvSpPr>
        <p:spPr>
          <a:xfrm>
            <a:off x="718567" y="3630769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1b: Progression-</a:t>
            </a:r>
            <a:r>
              <a:rPr lang="de-DE" dirty="0" err="1"/>
              <a:t>free</a:t>
            </a:r>
            <a:r>
              <a:rPr lang="de-DE" dirty="0"/>
              <a:t>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vs.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BFBFB33B-31F1-2846-B89C-C31834CED9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633" y="728138"/>
            <a:ext cx="8814900" cy="2675778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70C6F70E-7675-294C-BF33-BFF8227E69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567" y="4419592"/>
            <a:ext cx="8797966" cy="1897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2196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7F86DC20-81BE-C44A-A47C-E3FA37C330E3}"/>
              </a:ext>
            </a:extLst>
          </p:cNvPr>
          <p:cNvSpPr txBox="1"/>
          <p:nvPr/>
        </p:nvSpPr>
        <p:spPr>
          <a:xfrm>
            <a:off x="701633" y="220138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1c: Progression-</a:t>
            </a:r>
            <a:r>
              <a:rPr lang="de-DE" dirty="0" err="1"/>
              <a:t>free</a:t>
            </a:r>
            <a:r>
              <a:rPr lang="de-DE" dirty="0"/>
              <a:t>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argeted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</a:t>
            </a:r>
          </a:p>
          <a:p>
            <a:r>
              <a:rPr lang="de-DE" dirty="0"/>
              <a:t>vs.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argeted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xmlns="" id="{E8375992-5D49-DD4D-8942-13C3CE5403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1632" y="1051309"/>
            <a:ext cx="8510101" cy="1573358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CBE885CF-9247-0D47-83DE-326F1A9AB3B1}"/>
              </a:ext>
            </a:extLst>
          </p:cNvPr>
          <p:cNvSpPr txBox="1"/>
          <p:nvPr/>
        </p:nvSpPr>
        <p:spPr>
          <a:xfrm>
            <a:off x="701634" y="3589872"/>
            <a:ext cx="1021843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1d: Progression-</a:t>
            </a:r>
            <a:r>
              <a:rPr lang="de-DE" dirty="0" err="1"/>
              <a:t>free</a:t>
            </a:r>
            <a:r>
              <a:rPr lang="de-DE" dirty="0"/>
              <a:t> </a:t>
            </a:r>
            <a:r>
              <a:rPr lang="de-DE" dirty="0" err="1"/>
              <a:t>survival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EGFR </a:t>
            </a:r>
            <a:r>
              <a:rPr lang="de-DE" dirty="0" err="1"/>
              <a:t>therapy</a:t>
            </a:r>
            <a:r>
              <a:rPr lang="de-DE" dirty="0"/>
              <a:t> </a:t>
            </a:r>
          </a:p>
          <a:p>
            <a:r>
              <a:rPr lang="de-DE" dirty="0"/>
              <a:t>vs.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VEGFR </a:t>
            </a:r>
            <a:r>
              <a:rPr lang="de-DE" dirty="0" err="1"/>
              <a:t>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xmlns="" id="{C5012101-D62B-784B-83C3-627F2863AD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631" y="4409691"/>
            <a:ext cx="8510101" cy="1645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3427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88700289-86C4-C440-B68C-F230C2D72583}"/>
              </a:ext>
            </a:extLst>
          </p:cNvPr>
          <p:cNvSpPr txBox="1"/>
          <p:nvPr/>
        </p:nvSpPr>
        <p:spPr>
          <a:xfrm>
            <a:off x="718567" y="294911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2a : Overall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argeted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vs.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1BF0F22C-75AE-8F45-BCF6-D7A1416283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633" y="999085"/>
            <a:ext cx="8510100" cy="239731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0D2B5B5A-EE4F-7A49-B967-1D957F854320}"/>
              </a:ext>
            </a:extLst>
          </p:cNvPr>
          <p:cNvSpPr txBox="1"/>
          <p:nvPr/>
        </p:nvSpPr>
        <p:spPr>
          <a:xfrm>
            <a:off x="701633" y="3674536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2b: Overall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vs.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xmlns="" id="{A79EA03D-205D-584A-BF6A-0B69C12C75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567" y="4347614"/>
            <a:ext cx="8493166" cy="1763851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xmlns="" id="{4FEB7411-5EF3-8341-B1D8-BD5682CAA5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28883" y="4381480"/>
            <a:ext cx="1409908" cy="4106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104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7F86DC20-81BE-C44A-A47C-E3FA37C330E3}"/>
              </a:ext>
            </a:extLst>
          </p:cNvPr>
          <p:cNvSpPr txBox="1"/>
          <p:nvPr/>
        </p:nvSpPr>
        <p:spPr>
          <a:xfrm>
            <a:off x="701633" y="220138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2c: Overall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argeted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</a:t>
            </a:r>
          </a:p>
          <a:p>
            <a:r>
              <a:rPr lang="de-DE" dirty="0"/>
              <a:t>vs. </a:t>
            </a:r>
            <a:r>
              <a:rPr lang="de-DE" dirty="0" err="1"/>
              <a:t>trip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argeted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633B9668-D21A-3D41-9722-0B3F9E25BD47}"/>
              </a:ext>
            </a:extLst>
          </p:cNvPr>
          <p:cNvSpPr txBox="1"/>
          <p:nvPr/>
        </p:nvSpPr>
        <p:spPr>
          <a:xfrm>
            <a:off x="718567" y="3275176"/>
            <a:ext cx="10770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2d: Overall </a:t>
            </a:r>
            <a:r>
              <a:rPr lang="de-DE" dirty="0" err="1"/>
              <a:t>survival</a:t>
            </a:r>
            <a:r>
              <a:rPr lang="de-DE" dirty="0"/>
              <a:t> rat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tudies</a:t>
            </a:r>
            <a:r>
              <a:rPr lang="de-DE" dirty="0"/>
              <a:t>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VEGFR </a:t>
            </a:r>
            <a:r>
              <a:rPr lang="de-DE" dirty="0" err="1"/>
              <a:t>therapy</a:t>
            </a:r>
            <a:r>
              <a:rPr lang="de-DE" dirty="0"/>
              <a:t> </a:t>
            </a:r>
          </a:p>
          <a:p>
            <a:r>
              <a:rPr lang="de-DE" dirty="0"/>
              <a:t>vs. </a:t>
            </a:r>
            <a:r>
              <a:rPr lang="de-DE" dirty="0" err="1"/>
              <a:t>doublet</a:t>
            </a:r>
            <a:r>
              <a:rPr lang="de-DE" dirty="0"/>
              <a:t> </a:t>
            </a:r>
            <a:r>
              <a:rPr lang="de-DE" dirty="0" err="1"/>
              <a:t>chemotherapy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EGFR </a:t>
            </a:r>
            <a:r>
              <a:rPr lang="de-DE" dirty="0" err="1"/>
              <a:t>therapy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 </a:t>
            </a:r>
            <a:r>
              <a:rPr lang="de-DE" dirty="0" err="1"/>
              <a:t>colorectal</a:t>
            </a:r>
            <a:r>
              <a:rPr lang="de-DE" dirty="0"/>
              <a:t> </a:t>
            </a:r>
            <a:r>
              <a:rPr lang="de-DE" dirty="0" err="1"/>
              <a:t>cancer</a:t>
            </a:r>
            <a:r>
              <a:rPr lang="de-DE" dirty="0"/>
              <a:t>.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xmlns="" id="{9A50A328-E165-FB4E-8FBC-2FBDEFC2CA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1633" y="973538"/>
            <a:ext cx="8639012" cy="1712512"/>
          </a:xfrm>
          <a:prstGeom prst="rect">
            <a:avLst/>
          </a:prstGeom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116CF5BC-96B7-3047-B664-735F56EB72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4412" y="4235822"/>
            <a:ext cx="8476233" cy="1835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8948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5</Words>
  <Application>Microsoft Office PowerPoint</Application>
  <PresentationFormat>Widescreen</PresentationFormat>
  <Paragraphs>14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cp:lastModifiedBy>Mohamed Hussain M.</cp:lastModifiedBy>
  <cp:revision>2</cp:revision>
  <cp:lastPrinted>2023-05-31T08:29:53Z</cp:lastPrinted>
  <dcterms:modified xsi:type="dcterms:W3CDTF">2023-07-28T14:15:54Z</dcterms:modified>
</cp:coreProperties>
</file>